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5.xml" ContentType="application/vnd.ms-office.chartstyle+xml"/>
  <Override PartName="/ppt/charts/colors15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0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5.xml"/><Relationship Id="rId2" Type="http://schemas.microsoft.com/office/2011/relationships/chartColorStyle" Target="colors15.xml"/><Relationship Id="rId1" Type="http://schemas.openxmlformats.org/officeDocument/2006/relationships/oleObject" Target="file:///C:\Users\cmarx\Desktop\Auto_Densi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mexico\data\wang\homes\cmarx\Experiments\Flow%20Cytometry\ROS\AUY%20n3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cmarx\Desktop\ROS%20AU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v>WE-68</c:v>
          </c:tx>
          <c:spPr>
            <a:noFill/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3'!$G$16:$G$27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2.1414899691969964</c:v>
                  </c:pt>
                  <c:pt idx="2">
                    <c:v>9.8542885695861528</c:v>
                  </c:pt>
                  <c:pt idx="3">
                    <c:v>5.680338350246485</c:v>
                  </c:pt>
                  <c:pt idx="4">
                    <c:v>12.916306266862962</c:v>
                  </c:pt>
                  <c:pt idx="5">
                    <c:v>21.232062294197874</c:v>
                  </c:pt>
                  <c:pt idx="6">
                    <c:v>10.316943541958024</c:v>
                  </c:pt>
                  <c:pt idx="7">
                    <c:v>14.680766826310933</c:v>
                  </c:pt>
                  <c:pt idx="8">
                    <c:v>17.658222361374737</c:v>
                  </c:pt>
                  <c:pt idx="9">
                    <c:v>16.106472583401029</c:v>
                  </c:pt>
                  <c:pt idx="10">
                    <c:v>16.044740044446922</c:v>
                  </c:pt>
                  <c:pt idx="11">
                    <c:v>1.61212021362899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3'!$A$86:$B$97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n3'!$F$16:$F$27</c:f>
              <c:numCache>
                <c:formatCode>General</c:formatCode>
                <c:ptCount val="12"/>
                <c:pt idx="0">
                  <c:v>100</c:v>
                </c:pt>
                <c:pt idx="1">
                  <c:v>99.361772497216549</c:v>
                </c:pt>
                <c:pt idx="2">
                  <c:v>68.574988073214342</c:v>
                </c:pt>
                <c:pt idx="3">
                  <c:v>85.872609470258936</c:v>
                </c:pt>
                <c:pt idx="4">
                  <c:v>99.703071123365262</c:v>
                </c:pt>
                <c:pt idx="5">
                  <c:v>95.245173368556607</c:v>
                </c:pt>
                <c:pt idx="6">
                  <c:v>116.18068532907506</c:v>
                </c:pt>
                <c:pt idx="7">
                  <c:v>103.19254942752653</c:v>
                </c:pt>
                <c:pt idx="8">
                  <c:v>90.723818997862779</c:v>
                </c:pt>
                <c:pt idx="9">
                  <c:v>69.355654658381269</c:v>
                </c:pt>
                <c:pt idx="10">
                  <c:v>79.396105217761658</c:v>
                </c:pt>
                <c:pt idx="11">
                  <c:v>53.3149760581374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151-482E-B3F9-D633B9AC8712}"/>
            </c:ext>
          </c:extLst>
        </c:ser>
        <c:ser>
          <c:idx val="0"/>
          <c:order val="1"/>
          <c:tx>
            <c:v>A673</c:v>
          </c:tx>
          <c:spPr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3'!$P$16:$P$27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.2421212960272022</c:v>
                  </c:pt>
                  <c:pt idx="2">
                    <c:v>12.656812583693624</c:v>
                  </c:pt>
                  <c:pt idx="3">
                    <c:v>9.5229792896304115</c:v>
                  </c:pt>
                  <c:pt idx="4">
                    <c:v>19.845657637985827</c:v>
                  </c:pt>
                  <c:pt idx="5">
                    <c:v>8.2688010501862852</c:v>
                  </c:pt>
                  <c:pt idx="6">
                    <c:v>7.6892736629767828</c:v>
                  </c:pt>
                  <c:pt idx="7">
                    <c:v>6.5821164422489611</c:v>
                  </c:pt>
                  <c:pt idx="8">
                    <c:v>0.10968513688871238</c:v>
                  </c:pt>
                  <c:pt idx="9">
                    <c:v>13.206502439535855</c:v>
                  </c:pt>
                  <c:pt idx="10">
                    <c:v>3.4934259762050961</c:v>
                  </c:pt>
                  <c:pt idx="11">
                    <c:v>30.8287393289583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3'!$A$86:$B$97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n3'!$O$16:$O$27</c:f>
              <c:numCache>
                <c:formatCode>General</c:formatCode>
                <c:ptCount val="12"/>
                <c:pt idx="0">
                  <c:v>100</c:v>
                </c:pt>
                <c:pt idx="1">
                  <c:v>66.62121621847291</c:v>
                </c:pt>
                <c:pt idx="2">
                  <c:v>56.113072991018441</c:v>
                </c:pt>
                <c:pt idx="3">
                  <c:v>47.176618384154608</c:v>
                </c:pt>
                <c:pt idx="4">
                  <c:v>74.960026206880286</c:v>
                </c:pt>
                <c:pt idx="5">
                  <c:v>64.663910910386292</c:v>
                </c:pt>
                <c:pt idx="6">
                  <c:v>74.934837993203161</c:v>
                </c:pt>
                <c:pt idx="7">
                  <c:v>68.420040198695446</c:v>
                </c:pt>
                <c:pt idx="8">
                  <c:v>58.405604207839843</c:v>
                </c:pt>
                <c:pt idx="9">
                  <c:v>59.573256238356848</c:v>
                </c:pt>
                <c:pt idx="10">
                  <c:v>79.232931646730549</c:v>
                </c:pt>
                <c:pt idx="11">
                  <c:v>106.92502419710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151-482E-B3F9-D633B9AC87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667008"/>
        <c:axId val="38668544"/>
      </c:barChart>
      <c:catAx>
        <c:axId val="38667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668544"/>
        <c:crosses val="autoZero"/>
        <c:auto val="1"/>
        <c:lblAlgn val="ctr"/>
        <c:lblOffset val="100"/>
        <c:noMultiLvlLbl val="0"/>
      </c:catAx>
      <c:valAx>
        <c:axId val="386685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LAMP1 expression</a:t>
                </a:r>
              </a:p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(% to contro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66700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150455457773665"/>
          <c:y val="7.6388888888888895E-2"/>
          <c:w val="0.68222942720395241"/>
          <c:h val="0.74271945173519982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29:$I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1.936838982307286</c:v>
                  </c:pt>
                  <c:pt idx="2">
                    <c:v>15.219116397029287</c:v>
                  </c:pt>
                  <c:pt idx="3">
                    <c:v>3.838600735689135</c:v>
                  </c:pt>
                </c:numCache>
              </c:numRef>
            </c:plus>
            <c:minus>
              <c:numRef>
                <c:f>Sheet1!$I$29:$I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1.936838982307286</c:v>
                  </c:pt>
                  <c:pt idx="2">
                    <c:v>15.219116397029287</c:v>
                  </c:pt>
                  <c:pt idx="3">
                    <c:v>3.838600735689135</c:v>
                  </c:pt>
                </c:numCache>
              </c:numRef>
            </c:minus>
          </c:errBars>
          <c:xVal>
            <c:numRef>
              <c:f>Sheet1!$N$29:$N$32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H$29:$H$32</c:f>
              <c:numCache>
                <c:formatCode>General</c:formatCode>
                <c:ptCount val="4"/>
                <c:pt idx="0">
                  <c:v>100</c:v>
                </c:pt>
                <c:pt idx="1">
                  <c:v>87.24907563993186</c:v>
                </c:pt>
                <c:pt idx="2">
                  <c:v>84.450417205362228</c:v>
                </c:pt>
                <c:pt idx="3">
                  <c:v>68.08433760360479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0FE-4C13-9AA7-71AAE5A99C77}"/>
            </c:ext>
          </c:extLst>
        </c:ser>
        <c:ser>
          <c:idx val="1"/>
          <c:order val="1"/>
          <c:tx>
            <c:v>VE8221</c:v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33:$I$36</c:f>
                <c:numCache>
                  <c:formatCode>General</c:formatCode>
                  <c:ptCount val="4"/>
                  <c:pt idx="0">
                    <c:v>23.011534094649402</c:v>
                  </c:pt>
                  <c:pt idx="1">
                    <c:v>4.1116953167587678</c:v>
                  </c:pt>
                  <c:pt idx="2">
                    <c:v>18.475436910003367</c:v>
                  </c:pt>
                  <c:pt idx="3">
                    <c:v>9.950719694749699</c:v>
                  </c:pt>
                </c:numCache>
              </c:numRef>
            </c:plus>
            <c:minus>
              <c:numRef>
                <c:f>Sheet1!$I$33:$I$36</c:f>
                <c:numCache>
                  <c:formatCode>General</c:formatCode>
                  <c:ptCount val="4"/>
                  <c:pt idx="0">
                    <c:v>23.011534094649402</c:v>
                  </c:pt>
                  <c:pt idx="1">
                    <c:v>4.1116953167587678</c:v>
                  </c:pt>
                  <c:pt idx="2">
                    <c:v>18.475436910003367</c:v>
                  </c:pt>
                  <c:pt idx="3">
                    <c:v>9.950719694749699</c:v>
                  </c:pt>
                </c:numCache>
              </c:numRef>
            </c:minus>
          </c:errBars>
          <c:xVal>
            <c:numRef>
              <c:f>Sheet1!$N$29:$N$32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H$33:$H$36</c:f>
              <c:numCache>
                <c:formatCode>General</c:formatCode>
                <c:ptCount val="4"/>
                <c:pt idx="0">
                  <c:v>101.80585818907905</c:v>
                </c:pt>
                <c:pt idx="1">
                  <c:v>99.738820752907984</c:v>
                </c:pt>
                <c:pt idx="2">
                  <c:v>79.185662930217987</c:v>
                </c:pt>
                <c:pt idx="3">
                  <c:v>60.4739352409278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0FE-4C13-9AA7-71AAE5A99C77}"/>
            </c:ext>
          </c:extLst>
        </c:ser>
        <c:ser>
          <c:idx val="2"/>
          <c:order val="2"/>
          <c:tx>
            <c:v>KU55933</c:v>
          </c:tx>
          <c:spPr>
            <a:ln w="9525">
              <a:solidFill>
                <a:srgbClr val="00B050"/>
              </a:solidFill>
            </a:ln>
          </c:spPr>
          <c:marker>
            <c:symbol val="triangle"/>
            <c:size val="5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37:$I$40</c:f>
                <c:numCache>
                  <c:formatCode>General</c:formatCode>
                  <c:ptCount val="4"/>
                  <c:pt idx="0">
                    <c:v>17.891500534545678</c:v>
                  </c:pt>
                  <c:pt idx="1">
                    <c:v>15.643786945773037</c:v>
                  </c:pt>
                  <c:pt idx="2">
                    <c:v>10.5478749593067</c:v>
                  </c:pt>
                  <c:pt idx="3">
                    <c:v>13.650521585181092</c:v>
                  </c:pt>
                </c:numCache>
              </c:numRef>
            </c:plus>
            <c:minus>
              <c:numRef>
                <c:f>Sheet1!$I$37:$I$40</c:f>
                <c:numCache>
                  <c:formatCode>General</c:formatCode>
                  <c:ptCount val="4"/>
                  <c:pt idx="0">
                    <c:v>17.891500534545678</c:v>
                  </c:pt>
                  <c:pt idx="1">
                    <c:v>15.643786945773037</c:v>
                  </c:pt>
                  <c:pt idx="2">
                    <c:v>10.5478749593067</c:v>
                  </c:pt>
                  <c:pt idx="3">
                    <c:v>13.650521585181092</c:v>
                  </c:pt>
                </c:numCache>
              </c:numRef>
            </c:minus>
          </c:errBars>
          <c:xVal>
            <c:numRef>
              <c:f>Sheet1!$N$29:$N$32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H$37:$H$40</c:f>
              <c:numCache>
                <c:formatCode>General</c:formatCode>
                <c:ptCount val="4"/>
                <c:pt idx="0">
                  <c:v>110.81861917797043</c:v>
                </c:pt>
                <c:pt idx="1">
                  <c:v>136.61452978403415</c:v>
                </c:pt>
                <c:pt idx="2">
                  <c:v>95.894231371972424</c:v>
                </c:pt>
                <c:pt idx="3">
                  <c:v>95.5218292746164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0FE-4C13-9AA7-71AAE5A99C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700928"/>
        <c:axId val="38760448"/>
      </c:scatterChart>
      <c:valAx>
        <c:axId val="38700928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760448"/>
        <c:crosses val="autoZero"/>
        <c:crossBetween val="midCat"/>
        <c:majorUnit val="15"/>
      </c:valAx>
      <c:valAx>
        <c:axId val="38760448"/>
        <c:scaling>
          <c:orientation val="minMax"/>
          <c:max val="3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OS (% to contro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700928"/>
        <c:crosses val="autoZero"/>
        <c:crossBetween val="midCat"/>
        <c:majorUnit val="100"/>
        <c:minorUnit val="4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222368037328661"/>
          <c:y val="0.10185185185185185"/>
          <c:w val="0.62134149897929425"/>
          <c:h val="0.7063422280548266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OS AUY.xlsx]Sheet1'!$I$41:$I$4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8.900615693695279</c:v>
                  </c:pt>
                  <c:pt idx="2">
                    <c:v>49.930247462338855</c:v>
                  </c:pt>
                  <c:pt idx="3">
                    <c:v>45.473585958863765</c:v>
                  </c:pt>
                </c:numCache>
              </c:numRef>
            </c:plus>
            <c:minus>
              <c:numRef>
                <c:f>'[ROS AUY.xlsx]Sheet1'!$I$41:$I$4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8.900615693695279</c:v>
                  </c:pt>
                  <c:pt idx="2">
                    <c:v>49.930247462338855</c:v>
                  </c:pt>
                  <c:pt idx="3">
                    <c:v>45.473585958863765</c:v>
                  </c:pt>
                </c:numCache>
              </c:numRef>
            </c:minus>
          </c:errBars>
          <c:xVal>
            <c:numRef>
              <c:f>'[ROS AUY.xlsx]Sheet1'!$C$41:$C$44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'[ROS AUY.xlsx]Sheet1'!$H$41:$H$44</c:f>
              <c:numCache>
                <c:formatCode>General</c:formatCode>
                <c:ptCount val="4"/>
                <c:pt idx="0">
                  <c:v>100</c:v>
                </c:pt>
                <c:pt idx="1">
                  <c:v>157.11009112755178</c:v>
                </c:pt>
                <c:pt idx="2">
                  <c:v>205.39152128504341</c:v>
                </c:pt>
                <c:pt idx="3">
                  <c:v>201.294965959621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A46-4B6B-9F19-4F83947794F6}"/>
            </c:ext>
          </c:extLst>
        </c:ser>
        <c:ser>
          <c:idx val="1"/>
          <c:order val="1"/>
          <c:tx>
            <c:v>VE8221</c:v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OS AUY.xlsx]Sheet1'!$I$45:$I$48</c:f>
                <c:numCache>
                  <c:formatCode>General</c:formatCode>
                  <c:ptCount val="4"/>
                  <c:pt idx="0">
                    <c:v>27.542467124965768</c:v>
                  </c:pt>
                  <c:pt idx="1">
                    <c:v>43.145512762109639</c:v>
                  </c:pt>
                  <c:pt idx="2">
                    <c:v>62.05751357992304</c:v>
                  </c:pt>
                  <c:pt idx="3">
                    <c:v>37.701794228499608</c:v>
                  </c:pt>
                </c:numCache>
              </c:numRef>
            </c:plus>
            <c:minus>
              <c:numRef>
                <c:f>'[ROS AUY.xlsx]Sheet1'!$I$45:$I$48</c:f>
                <c:numCache>
                  <c:formatCode>General</c:formatCode>
                  <c:ptCount val="4"/>
                  <c:pt idx="0">
                    <c:v>27.542467124965768</c:v>
                  </c:pt>
                  <c:pt idx="1">
                    <c:v>43.145512762109639</c:v>
                  </c:pt>
                  <c:pt idx="2">
                    <c:v>62.05751357992304</c:v>
                  </c:pt>
                  <c:pt idx="3">
                    <c:v>37.701794228499608</c:v>
                  </c:pt>
                </c:numCache>
              </c:numRef>
            </c:minus>
          </c:errBars>
          <c:xVal>
            <c:numRef>
              <c:f>'[ROS AUY.xlsx]Sheet1'!$C$45:$C$4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'[ROS AUY.xlsx]Sheet1'!$H$45:$H$48</c:f>
              <c:numCache>
                <c:formatCode>General</c:formatCode>
                <c:ptCount val="4"/>
                <c:pt idx="0">
                  <c:v>114.4123353976335</c:v>
                </c:pt>
                <c:pt idx="1">
                  <c:v>144.46914945075517</c:v>
                </c:pt>
                <c:pt idx="2">
                  <c:v>218.74522978946675</c:v>
                </c:pt>
                <c:pt idx="3">
                  <c:v>163.7275571460572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A46-4B6B-9F19-4F83947794F6}"/>
            </c:ext>
          </c:extLst>
        </c:ser>
        <c:ser>
          <c:idx val="2"/>
          <c:order val="2"/>
          <c:tx>
            <c:v>KU55933</c:v>
          </c:tx>
          <c:spPr>
            <a:ln w="9525">
              <a:solidFill>
                <a:srgbClr val="00B050"/>
              </a:solidFill>
            </a:ln>
          </c:spPr>
          <c:marker>
            <c:symbol val="triangle"/>
            <c:size val="5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OS AUY.xlsx]Sheet1'!$I$49:$I$52</c:f>
                <c:numCache>
                  <c:formatCode>General</c:formatCode>
                  <c:ptCount val="4"/>
                  <c:pt idx="0">
                    <c:v>8.1622864764995722</c:v>
                  </c:pt>
                  <c:pt idx="1">
                    <c:v>42.83367265483016</c:v>
                  </c:pt>
                  <c:pt idx="2">
                    <c:v>55.016481520555764</c:v>
                  </c:pt>
                  <c:pt idx="3">
                    <c:v>33.874806399647888</c:v>
                  </c:pt>
                </c:numCache>
              </c:numRef>
            </c:plus>
            <c:minus>
              <c:numRef>
                <c:f>'[ROS AUY.xlsx]Sheet1'!$I$49:$I$52</c:f>
                <c:numCache>
                  <c:formatCode>General</c:formatCode>
                  <c:ptCount val="4"/>
                  <c:pt idx="0">
                    <c:v>8.1622864764995722</c:v>
                  </c:pt>
                  <c:pt idx="1">
                    <c:v>42.83367265483016</c:v>
                  </c:pt>
                  <c:pt idx="2">
                    <c:v>55.016481520555764</c:v>
                  </c:pt>
                  <c:pt idx="3">
                    <c:v>33.874806399647888</c:v>
                  </c:pt>
                </c:numCache>
              </c:numRef>
            </c:minus>
          </c:errBars>
          <c:xVal>
            <c:numRef>
              <c:f>'[ROS AUY.xlsx]Sheet1'!$C$49:$C$52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'[ROS AUY.xlsx]Sheet1'!$H$49:$H$52</c:f>
              <c:numCache>
                <c:formatCode>General</c:formatCode>
                <c:ptCount val="4"/>
                <c:pt idx="0">
                  <c:v>114.01030217917777</c:v>
                </c:pt>
                <c:pt idx="1">
                  <c:v>197.65097530150845</c:v>
                </c:pt>
                <c:pt idx="2">
                  <c:v>182.22963684230953</c:v>
                </c:pt>
                <c:pt idx="3">
                  <c:v>180.3223065638041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A46-4B6B-9F19-4F83947794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887424"/>
        <c:axId val="38889344"/>
      </c:scatterChart>
      <c:valAx>
        <c:axId val="38887424"/>
        <c:scaling>
          <c:orientation val="minMax"/>
          <c:max val="45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889344"/>
        <c:crosses val="autoZero"/>
        <c:crossBetween val="midCat"/>
        <c:majorUnit val="15"/>
      </c:valAx>
      <c:valAx>
        <c:axId val="38889344"/>
        <c:scaling>
          <c:orientation val="minMax"/>
          <c:max val="3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OS (% to contro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887424"/>
        <c:crosses val="autoZero"/>
        <c:crossBetween val="midCat"/>
        <c:majorUnit val="100"/>
        <c:minorUnit val="4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308</cdr:x>
      <cdr:y>0.62939</cdr:y>
    </cdr:from>
    <cdr:to>
      <cdr:x>0.47787</cdr:x>
      <cdr:y>0.8038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19689" y="863271"/>
          <a:ext cx="335754" cy="2392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600" b="0">
              <a:latin typeface="Arial" panose="020B0604020202020204" pitchFamily="34" charset="0"/>
              <a:cs typeface="Arial" panose="020B0604020202020204" pitchFamily="34" charset="0"/>
            </a:rPr>
            <a:t>24 h</a:t>
          </a:r>
        </a:p>
        <a:p xmlns:a="http://schemas.openxmlformats.org/drawingml/2006/main">
          <a:pPr algn="ctr"/>
          <a:r>
            <a:rPr lang="en-US" sz="600" b="0">
              <a:latin typeface="Arial" panose="020B0604020202020204" pitchFamily="34" charset="0"/>
              <a:cs typeface="Arial" panose="020B0604020202020204" pitchFamily="34" charset="0"/>
            </a:rPr>
            <a:t>WE-68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9597</cdr:x>
      <cdr:y>0.62036</cdr:y>
    </cdr:from>
    <cdr:to>
      <cdr:x>0.54076</cdr:x>
      <cdr:y>0.7974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05956" y="850888"/>
          <a:ext cx="335754" cy="2428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600" b="0">
              <a:latin typeface="Arial" panose="020B0604020202020204" pitchFamily="34" charset="0"/>
              <a:cs typeface="Arial" panose="020B0604020202020204" pitchFamily="34" charset="0"/>
            </a:rPr>
            <a:t>24 h</a:t>
          </a:r>
        </a:p>
        <a:p xmlns:a="http://schemas.openxmlformats.org/drawingml/2006/main">
          <a:pPr algn="ctr"/>
          <a:r>
            <a:rPr lang="en-US" sz="600" b="0">
              <a:latin typeface="Arial" panose="020B0604020202020204" pitchFamily="34" charset="0"/>
              <a:cs typeface="Arial" panose="020B0604020202020204" pitchFamily="34" charset="0"/>
            </a:rPr>
            <a:t>A673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9.png"/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12" Type="http://schemas.openxmlformats.org/officeDocument/2006/relationships/image" Target="../media/image8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1" Type="http://schemas.openxmlformats.org/officeDocument/2006/relationships/image" Target="../media/image7.png"/><Relationship Id="rId5" Type="http://schemas.openxmlformats.org/officeDocument/2006/relationships/image" Target="../media/image1.png"/><Relationship Id="rId10" Type="http://schemas.openxmlformats.org/officeDocument/2006/relationships/image" Target="../media/image6.png"/><Relationship Id="rId4" Type="http://schemas.openxmlformats.org/officeDocument/2006/relationships/chart" Target="../charts/chart3.xml"/><Relationship Id="rId9" Type="http://schemas.openxmlformats.org/officeDocument/2006/relationships/image" Target="../media/image5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14">
            <a:extLst>
              <a:ext uri="{FF2B5EF4-FFF2-40B4-BE49-F238E27FC236}">
                <a16:creationId xmlns="" xmlns:a16="http://schemas.microsoft.com/office/drawing/2014/main" id="{B97F3B0B-964A-A847-9C10-830B71E6A5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9170777"/>
              </p:ext>
            </p:extLst>
          </p:nvPr>
        </p:nvGraphicFramePr>
        <p:xfrm>
          <a:off x="183447" y="2137200"/>
          <a:ext cx="2340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feld 115">
            <a:extLst>
              <a:ext uri="{FF2B5EF4-FFF2-40B4-BE49-F238E27FC236}">
                <a16:creationId xmlns="" xmlns:a16="http://schemas.microsoft.com/office/drawing/2014/main" id="{A43B4373-0F03-B844-B95D-741E7813E855}"/>
              </a:ext>
            </a:extLst>
          </p:cNvPr>
          <p:cNvSpPr txBox="1"/>
          <p:nvPr/>
        </p:nvSpPr>
        <p:spPr>
          <a:xfrm>
            <a:off x="528144" y="32529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4" name="TextBox 198">
            <a:extLst>
              <a:ext uri="{FF2B5EF4-FFF2-40B4-BE49-F238E27FC236}">
                <a16:creationId xmlns="" xmlns:a16="http://schemas.microsoft.com/office/drawing/2014/main" id="{B3F5CA6B-35D5-3F4E-8879-2DA2B1CBE5B4}"/>
              </a:ext>
            </a:extLst>
          </p:cNvPr>
          <p:cNvSpPr txBox="1"/>
          <p:nvPr/>
        </p:nvSpPr>
        <p:spPr>
          <a:xfrm>
            <a:off x="159448" y="20340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124">
            <a:extLst>
              <a:ext uri="{FF2B5EF4-FFF2-40B4-BE49-F238E27FC236}">
                <a16:creationId xmlns="" xmlns:a16="http://schemas.microsoft.com/office/drawing/2014/main" id="{4AB9C5F7-9E69-2747-8216-5CEED8D5D4B3}"/>
              </a:ext>
            </a:extLst>
          </p:cNvPr>
          <p:cNvSpPr txBox="1"/>
          <p:nvPr/>
        </p:nvSpPr>
        <p:spPr>
          <a:xfrm>
            <a:off x="705104" y="211610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□ WE-68</a:t>
            </a:r>
          </a:p>
          <a:p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graphicFrame>
        <p:nvGraphicFramePr>
          <p:cNvPr id="44" name="Chart 154">
            <a:extLst>
              <a:ext uri="{FF2B5EF4-FFF2-40B4-BE49-F238E27FC236}">
                <a16:creationId xmlns="" xmlns:a16="http://schemas.microsoft.com/office/drawing/2014/main" id="{B29DDC3F-6849-0648-AD83-0BCB409928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2639693"/>
              </p:ext>
            </p:extLst>
          </p:nvPr>
        </p:nvGraphicFramePr>
        <p:xfrm>
          <a:off x="352623" y="626146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5" name="TextBox 156">
            <a:extLst>
              <a:ext uri="{FF2B5EF4-FFF2-40B4-BE49-F238E27FC236}">
                <a16:creationId xmlns="" xmlns:a16="http://schemas.microsoft.com/office/drawing/2014/main" id="{4B22FFFA-3C1E-7349-855F-72617D887F3F}"/>
              </a:ext>
            </a:extLst>
          </p:cNvPr>
          <p:cNvSpPr txBox="1"/>
          <p:nvPr/>
        </p:nvSpPr>
        <p:spPr>
          <a:xfrm>
            <a:off x="1121179" y="624306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 ● DMSO</a:t>
            </a:r>
          </a:p>
          <a:p>
            <a:r>
              <a:rPr lang="en-US" sz="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■ </a:t>
            </a:r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VE821</a:t>
            </a:r>
            <a:endParaRPr lang="en-US" sz="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6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▲ </a:t>
            </a:r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KU55933</a:t>
            </a:r>
            <a:endParaRPr lang="en-US" sz="60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Chart 157">
            <a:extLst>
              <a:ext uri="{FF2B5EF4-FFF2-40B4-BE49-F238E27FC236}">
                <a16:creationId xmlns="" xmlns:a16="http://schemas.microsoft.com/office/drawing/2014/main" id="{00B94C88-27F2-4C41-A970-AEEFE3E159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5813589"/>
              </p:ext>
            </p:extLst>
          </p:nvPr>
        </p:nvGraphicFramePr>
        <p:xfrm>
          <a:off x="1716337" y="626146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7" name="Textfeld 112">
            <a:extLst>
              <a:ext uri="{FF2B5EF4-FFF2-40B4-BE49-F238E27FC236}">
                <a16:creationId xmlns="" xmlns:a16="http://schemas.microsoft.com/office/drawing/2014/main" id="{44C4419A-24E9-974C-9EB2-E7F46480C2D8}"/>
              </a:ext>
            </a:extLst>
          </p:cNvPr>
          <p:cNvSpPr txBox="1"/>
          <p:nvPr/>
        </p:nvSpPr>
        <p:spPr>
          <a:xfrm>
            <a:off x="624496" y="6560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48" name="Textfeld 113">
            <a:extLst>
              <a:ext uri="{FF2B5EF4-FFF2-40B4-BE49-F238E27FC236}">
                <a16:creationId xmlns="" xmlns:a16="http://schemas.microsoft.com/office/drawing/2014/main" id="{42965670-BA7C-EF4F-BED3-916ED68ABDAD}"/>
              </a:ext>
            </a:extLst>
          </p:cNvPr>
          <p:cNvSpPr txBox="1"/>
          <p:nvPr/>
        </p:nvSpPr>
        <p:spPr>
          <a:xfrm>
            <a:off x="2067720" y="7086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49" name="TextBox 198">
            <a:extLst>
              <a:ext uri="{FF2B5EF4-FFF2-40B4-BE49-F238E27FC236}">
                <a16:creationId xmlns="" xmlns:a16="http://schemas.microsoft.com/office/drawing/2014/main" id="{B3F5CA6B-35D5-3F4E-8879-2DA2B1CBE5B4}"/>
              </a:ext>
            </a:extLst>
          </p:cNvPr>
          <p:cNvSpPr txBox="1"/>
          <p:nvPr/>
        </p:nvSpPr>
        <p:spPr>
          <a:xfrm>
            <a:off x="3081488" y="5334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Rechteck 2">
            <a:extLst>
              <a:ext uri="{FF2B5EF4-FFF2-40B4-BE49-F238E27FC236}">
                <a16:creationId xmlns="" xmlns:a16="http://schemas.microsoft.com/office/drawing/2014/main" id="{80797562-EE27-8043-8DCD-98BD1F54AE3A}"/>
              </a:ext>
            </a:extLst>
          </p:cNvPr>
          <p:cNvSpPr/>
          <p:nvPr/>
        </p:nvSpPr>
        <p:spPr>
          <a:xfrm>
            <a:off x="204473" y="3853696"/>
            <a:ext cx="6270023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 of ER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WE-68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nd 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5-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f AUY922, 2 µM of VE821, 5 µM of KU55933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4 h. (A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tracellula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xyg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ROS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CM-H</a:t>
            </a:r>
            <a:r>
              <a:rPr lang="de-DE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DCFDA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aph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± SEM of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f LAMP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± SEM of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(C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therwi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sogenic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p53 wild-type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and p53 null (p53-/-) HCT116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± 2 µM VE8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4 h. Analysi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⍺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76" name="TextBox 198">
            <a:extLst>
              <a:ext uri="{FF2B5EF4-FFF2-40B4-BE49-F238E27FC236}">
                <a16:creationId xmlns="" xmlns:a16="http://schemas.microsoft.com/office/drawing/2014/main" id="{B3F5CA6B-35D5-3F4E-8879-2DA2B1CBE5B4}"/>
              </a:ext>
            </a:extLst>
          </p:cNvPr>
          <p:cNvSpPr txBox="1"/>
          <p:nvPr/>
        </p:nvSpPr>
        <p:spPr>
          <a:xfrm>
            <a:off x="153486" y="5334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237834" y="624306"/>
            <a:ext cx="1845859" cy="2701933"/>
            <a:chOff x="261148" y="663220"/>
            <a:chExt cx="1845859" cy="2701933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5633" y="3048000"/>
              <a:ext cx="1332000" cy="14871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2492" y="1564690"/>
              <a:ext cx="1327325" cy="296568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2492" y="1897843"/>
              <a:ext cx="1327325" cy="15587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2492" y="2092297"/>
              <a:ext cx="1327325" cy="93669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326103" y="2024529"/>
              <a:ext cx="510484" cy="206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78503" y="1874512"/>
              <a:ext cx="351182" cy="206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23" name="Flowchart: Extract 22"/>
            <p:cNvSpPr/>
            <p:nvPr/>
          </p:nvSpPr>
          <p:spPr>
            <a:xfrm rot="5400000">
              <a:off x="700534" y="1577692"/>
              <a:ext cx="34176" cy="34176"/>
            </a:xfrm>
            <a:prstGeom prst="flowChartExtra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8235" y="1619379"/>
              <a:ext cx="444257" cy="309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BIM-L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BIM-S</a:t>
              </a:r>
            </a:p>
          </p:txBody>
        </p:sp>
        <p:sp>
          <p:nvSpPr>
            <p:cNvPr id="25" name="Flowchart: Extract 24"/>
            <p:cNvSpPr/>
            <p:nvPr/>
          </p:nvSpPr>
          <p:spPr>
            <a:xfrm rot="5400000">
              <a:off x="708385" y="1715287"/>
              <a:ext cx="34176" cy="34176"/>
            </a:xfrm>
            <a:prstGeom prst="flowChartExtra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Flowchart: Extract 25"/>
            <p:cNvSpPr/>
            <p:nvPr/>
          </p:nvSpPr>
          <p:spPr>
            <a:xfrm rot="5400000">
              <a:off x="708385" y="1795030"/>
              <a:ext cx="34176" cy="34176"/>
            </a:xfrm>
            <a:prstGeom prst="flowChartExtra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91744" y="1492829"/>
              <a:ext cx="492584" cy="206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BIM-EL</a:t>
              </a:r>
            </a:p>
          </p:txBody>
        </p:sp>
        <p:cxnSp>
          <p:nvCxnSpPr>
            <p:cNvPr id="28" name="Straight Connector 27"/>
            <p:cNvCxnSpPr>
              <a:stCxn id="18" idx="0"/>
              <a:endCxn id="20" idx="2"/>
            </p:cNvCxnSpPr>
            <p:nvPr/>
          </p:nvCxnSpPr>
          <p:spPr>
            <a:xfrm>
              <a:off x="1436155" y="1564690"/>
              <a:ext cx="0" cy="621277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307509" y="827049"/>
              <a:ext cx="516084" cy="302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UY922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96049" y="663220"/>
              <a:ext cx="622643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CT116 </a:t>
              </a:r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903427" y="822462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068577" y="930824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079064" y="816647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913914" y="930304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86254" y="821942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89752" y="930304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222072" y="927735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221035" y="821607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35531" y="817502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700682" y="925863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711169" y="811686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546018" y="925343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418359" y="816982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421856" y="925343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854176" y="922774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853139" y="816647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61" name="Straight Connector 60"/>
            <p:cNvCxnSpPr/>
            <p:nvPr/>
          </p:nvCxnSpPr>
          <p:spPr>
            <a:xfrm>
              <a:off x="867362" y="821607"/>
              <a:ext cx="49856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1499141" y="823672"/>
              <a:ext cx="49856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1345504" y="667806"/>
              <a:ext cx="758988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CT116 p53-/-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13761" y="1328874"/>
              <a:ext cx="498535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61148" y="1121182"/>
              <a:ext cx="4459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C3B-I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C3B-II</a:t>
              </a:r>
            </a:p>
          </p:txBody>
        </p:sp>
        <p:sp>
          <p:nvSpPr>
            <p:cNvPr id="72" name="Flowchart: Extract 71"/>
            <p:cNvSpPr/>
            <p:nvPr/>
          </p:nvSpPr>
          <p:spPr>
            <a:xfrm rot="5400000">
              <a:off x="684495" y="1202975"/>
              <a:ext cx="33376" cy="33376"/>
            </a:xfrm>
            <a:prstGeom prst="flowChartExtra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Flowchart: Extract 72"/>
            <p:cNvSpPr/>
            <p:nvPr/>
          </p:nvSpPr>
          <p:spPr>
            <a:xfrm rot="5400000">
              <a:off x="684495" y="1280852"/>
              <a:ext cx="33376" cy="33376"/>
            </a:xfrm>
            <a:prstGeom prst="flowChartExtra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2492" y="1152632"/>
              <a:ext cx="1332000" cy="17920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2492" y="1350593"/>
              <a:ext cx="1332000" cy="133644"/>
            </a:xfrm>
            <a:prstGeom prst="rect">
              <a:avLst/>
            </a:prstGeom>
          </p:spPr>
        </p:pic>
        <p:cxnSp>
          <p:nvCxnSpPr>
            <p:cNvPr id="75" name="Straight Connector 74"/>
            <p:cNvCxnSpPr>
              <a:cxnSpLocks/>
              <a:stCxn id="6" idx="0"/>
              <a:endCxn id="7" idx="2"/>
            </p:cNvCxnSpPr>
            <p:nvPr/>
          </p:nvCxnSpPr>
          <p:spPr>
            <a:xfrm>
              <a:off x="1438492" y="1152632"/>
              <a:ext cx="0" cy="331605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4571" y="2286000"/>
              <a:ext cx="1332000" cy="204198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5007" y="2512168"/>
              <a:ext cx="1332000" cy="134063"/>
            </a:xfrm>
            <a:prstGeom prst="rect">
              <a:avLst/>
            </a:prstGeom>
          </p:spPr>
        </p:pic>
        <p:sp>
          <p:nvSpPr>
            <p:cNvPr id="77" name="TextBox 76"/>
            <p:cNvSpPr txBox="1"/>
            <p:nvPr/>
          </p:nvSpPr>
          <p:spPr>
            <a:xfrm>
              <a:off x="478503" y="2460470"/>
              <a:ext cx="3401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DR5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02303" y="2291656"/>
              <a:ext cx="4379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AMP1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4571" y="2674899"/>
              <a:ext cx="1332000" cy="169207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73795" y="2873346"/>
              <a:ext cx="1332000" cy="151639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380720" y="2658667"/>
              <a:ext cx="4379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RP78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31819" y="2837915"/>
              <a:ext cx="39786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TF-4</a:t>
              </a:r>
            </a:p>
          </p:txBody>
        </p:sp>
        <p:cxnSp>
          <p:nvCxnSpPr>
            <p:cNvPr id="66" name="Straight Connector 65"/>
            <p:cNvCxnSpPr>
              <a:endCxn id="12" idx="2"/>
            </p:cNvCxnSpPr>
            <p:nvPr/>
          </p:nvCxnSpPr>
          <p:spPr>
            <a:xfrm flipH="1">
              <a:off x="1431633" y="2285999"/>
              <a:ext cx="16041" cy="910711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333030" y="3028460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274258" y="3180487"/>
              <a:ext cx="3025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</p:grpSp>
      <p:sp>
        <p:nvSpPr>
          <p:cNvPr id="67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9601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8</Words>
  <Application>Microsoft Office PowerPoint</Application>
  <PresentationFormat>A4-Papier (210x297 mm)</PresentationFormat>
  <Paragraphs>5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8:17Z</dcterms:modified>
</cp:coreProperties>
</file>